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宮尾 安藝雄" initials="宮尾" lastIdx="1" clrIdx="0">
    <p:extLst>
      <p:ext uri="{19B8F6BF-5375-455C-9EA6-DF929625EA0E}">
        <p15:presenceInfo xmlns:p15="http://schemas.microsoft.com/office/powerpoint/2012/main" userId="980aa331686f292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144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4781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9221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1673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4260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6299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1664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201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6577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7922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0183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1995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7610F-5C30-4C02-9866-FC0E8D83C73B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0510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A27FE7D0-4085-487A-95EA-918EDA83EE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922" y="1097131"/>
            <a:ext cx="4593599" cy="1584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BF999FE6-1DD9-47D9-9733-12EE6A6B13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85356" y="1097131"/>
            <a:ext cx="4627474" cy="15840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0269EADD-E4D5-47C3-8DFF-F598E7409F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4922" y="2990168"/>
            <a:ext cx="4637072" cy="15840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4B762D48-3ADA-4306-ADDA-50C41D42EC8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85356" y="2990168"/>
            <a:ext cx="4617507" cy="1584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2230CF4-B52F-4EC5-AC48-EC353BFBDA90}"/>
              </a:ext>
            </a:extLst>
          </p:cNvPr>
          <p:cNvSpPr txBox="1"/>
          <p:nvPr/>
        </p:nvSpPr>
        <p:spPr>
          <a:xfrm>
            <a:off x="1279861" y="5068371"/>
            <a:ext cx="726814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Figure S1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游明朝" panose="02020400000000000000" pitchFamily="18" charset="-128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TE transpositions in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Arabidopsis thaliana.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 Heat treated lines hc31 and hc4 show transposition of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ONSEN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. DRR001193 and DRR00194 are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ddm1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 mutants. Transpositions of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CACTA, Evade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 and AT2G13940 are shown.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游明朝" panose="02020400000000000000" pitchFamily="18" charset="-128"/>
            </a:endParaRPr>
          </a:p>
          <a:p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17973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72</TotalTime>
  <Words>36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尾 安藝雄</dc:creator>
  <cp:lastModifiedBy>宮尾 安藝雄</cp:lastModifiedBy>
  <cp:revision>57</cp:revision>
  <dcterms:created xsi:type="dcterms:W3CDTF">2021-08-02T08:50:08Z</dcterms:created>
  <dcterms:modified xsi:type="dcterms:W3CDTF">2022-06-06T01:17:27Z</dcterms:modified>
</cp:coreProperties>
</file>